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08" r:id="rId1"/>
  </p:sldMasterIdLst>
  <p:notesMasterIdLst>
    <p:notesMasterId r:id="rId3"/>
  </p:notesMasterIdLst>
  <p:sldIdLst>
    <p:sldId id="259" r:id="rId2"/>
  </p:sldIdLst>
  <p:sldSz cx="5400675" cy="39592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247" userDrawn="1">
          <p15:clr>
            <a:srgbClr val="A4A3A4"/>
          </p15:clr>
        </p15:guide>
        <p15:guide id="2" pos="170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715"/>
    <p:restoredTop sz="94536"/>
  </p:normalViewPr>
  <p:slideViewPr>
    <p:cSldViewPr snapToGrid="0" showGuides="1">
      <p:cViewPr varScale="1">
        <p:scale>
          <a:sx n="264" d="100"/>
          <a:sy n="264" d="100"/>
        </p:scale>
        <p:origin x="2600" y="168"/>
      </p:cViewPr>
      <p:guideLst>
        <p:guide orient="horz" pos="1247"/>
        <p:guide pos="170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28B3DC4-9CF6-154E-B92E-8F9AD349A80C}" type="datetimeFigureOut">
              <a:rPr kumimoji="1" lang="ja-JP" altLang="en-US" smtClean="0"/>
              <a:t>2023/7/3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25563" y="1143000"/>
            <a:ext cx="42068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36AD6B4-BB94-714E-BB11-9D8B3A2B40A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7212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63247" rtl="0" eaLnBrk="1" latinLnBrk="0" hangingPunct="1">
      <a:defRPr kumimoji="1" sz="608" kern="1200">
        <a:solidFill>
          <a:schemeClr val="tx1"/>
        </a:solidFill>
        <a:latin typeface="+mn-lt"/>
        <a:ea typeface="+mn-ea"/>
        <a:cs typeface="+mn-cs"/>
      </a:defRPr>
    </a:lvl1pPr>
    <a:lvl2pPr marL="231623" algn="l" defTabSz="463247" rtl="0" eaLnBrk="1" latinLnBrk="0" hangingPunct="1">
      <a:defRPr kumimoji="1" sz="608" kern="1200">
        <a:solidFill>
          <a:schemeClr val="tx1"/>
        </a:solidFill>
        <a:latin typeface="+mn-lt"/>
        <a:ea typeface="+mn-ea"/>
        <a:cs typeface="+mn-cs"/>
      </a:defRPr>
    </a:lvl2pPr>
    <a:lvl3pPr marL="463247" algn="l" defTabSz="463247" rtl="0" eaLnBrk="1" latinLnBrk="0" hangingPunct="1">
      <a:defRPr kumimoji="1" sz="608" kern="1200">
        <a:solidFill>
          <a:schemeClr val="tx1"/>
        </a:solidFill>
        <a:latin typeface="+mn-lt"/>
        <a:ea typeface="+mn-ea"/>
        <a:cs typeface="+mn-cs"/>
      </a:defRPr>
    </a:lvl3pPr>
    <a:lvl4pPr marL="694870" algn="l" defTabSz="463247" rtl="0" eaLnBrk="1" latinLnBrk="0" hangingPunct="1">
      <a:defRPr kumimoji="1" sz="608" kern="1200">
        <a:solidFill>
          <a:schemeClr val="tx1"/>
        </a:solidFill>
        <a:latin typeface="+mn-lt"/>
        <a:ea typeface="+mn-ea"/>
        <a:cs typeface="+mn-cs"/>
      </a:defRPr>
    </a:lvl4pPr>
    <a:lvl5pPr marL="926493" algn="l" defTabSz="463247" rtl="0" eaLnBrk="1" latinLnBrk="0" hangingPunct="1">
      <a:defRPr kumimoji="1" sz="608" kern="1200">
        <a:solidFill>
          <a:schemeClr val="tx1"/>
        </a:solidFill>
        <a:latin typeface="+mn-lt"/>
        <a:ea typeface="+mn-ea"/>
        <a:cs typeface="+mn-cs"/>
      </a:defRPr>
    </a:lvl5pPr>
    <a:lvl6pPr marL="1158117" algn="l" defTabSz="463247" rtl="0" eaLnBrk="1" latinLnBrk="0" hangingPunct="1">
      <a:defRPr kumimoji="1" sz="608" kern="1200">
        <a:solidFill>
          <a:schemeClr val="tx1"/>
        </a:solidFill>
        <a:latin typeface="+mn-lt"/>
        <a:ea typeface="+mn-ea"/>
        <a:cs typeface="+mn-cs"/>
      </a:defRPr>
    </a:lvl6pPr>
    <a:lvl7pPr marL="1389740" algn="l" defTabSz="463247" rtl="0" eaLnBrk="1" latinLnBrk="0" hangingPunct="1">
      <a:defRPr kumimoji="1" sz="608" kern="1200">
        <a:solidFill>
          <a:schemeClr val="tx1"/>
        </a:solidFill>
        <a:latin typeface="+mn-lt"/>
        <a:ea typeface="+mn-ea"/>
        <a:cs typeface="+mn-cs"/>
      </a:defRPr>
    </a:lvl7pPr>
    <a:lvl8pPr marL="1621363" algn="l" defTabSz="463247" rtl="0" eaLnBrk="1" latinLnBrk="0" hangingPunct="1">
      <a:defRPr kumimoji="1" sz="608" kern="1200">
        <a:solidFill>
          <a:schemeClr val="tx1"/>
        </a:solidFill>
        <a:latin typeface="+mn-lt"/>
        <a:ea typeface="+mn-ea"/>
        <a:cs typeface="+mn-cs"/>
      </a:defRPr>
    </a:lvl8pPr>
    <a:lvl9pPr marL="1852986" algn="l" defTabSz="463247" rtl="0" eaLnBrk="1" latinLnBrk="0" hangingPunct="1">
      <a:defRPr kumimoji="1" sz="608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1325563" y="1143000"/>
            <a:ext cx="4206875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36AD6B4-BB94-714E-BB11-9D8B3A2B40A0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63771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05051" y="647957"/>
            <a:ext cx="4590574" cy="1378397"/>
          </a:xfrm>
        </p:spPr>
        <p:txBody>
          <a:bodyPr anchor="b"/>
          <a:lstStyle>
            <a:lvl1pPr algn="ctr">
              <a:defRPr sz="346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75085" y="2079510"/>
            <a:ext cx="4050506" cy="955896"/>
          </a:xfrm>
        </p:spPr>
        <p:txBody>
          <a:bodyPr/>
          <a:lstStyle>
            <a:lvl1pPr marL="0" indent="0" algn="ctr">
              <a:buNone/>
              <a:defRPr sz="1386"/>
            </a:lvl1pPr>
            <a:lvl2pPr marL="263942" indent="0" algn="ctr">
              <a:buNone/>
              <a:defRPr sz="1155"/>
            </a:lvl2pPr>
            <a:lvl3pPr marL="527883" indent="0" algn="ctr">
              <a:buNone/>
              <a:defRPr sz="1039"/>
            </a:lvl3pPr>
            <a:lvl4pPr marL="791825" indent="0" algn="ctr">
              <a:buNone/>
              <a:defRPr sz="924"/>
            </a:lvl4pPr>
            <a:lvl5pPr marL="1055766" indent="0" algn="ctr">
              <a:buNone/>
              <a:defRPr sz="924"/>
            </a:lvl5pPr>
            <a:lvl6pPr marL="1319708" indent="0" algn="ctr">
              <a:buNone/>
              <a:defRPr sz="924"/>
            </a:lvl6pPr>
            <a:lvl7pPr marL="1583649" indent="0" algn="ctr">
              <a:buNone/>
              <a:defRPr sz="924"/>
            </a:lvl7pPr>
            <a:lvl8pPr marL="1847591" indent="0" algn="ctr">
              <a:buNone/>
              <a:defRPr sz="924"/>
            </a:lvl8pPr>
            <a:lvl9pPr marL="2111532" indent="0" algn="ctr">
              <a:buNone/>
              <a:defRPr sz="924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A1566-B2AB-954F-986E-F27DA3D5F79C}" type="datetimeFigureOut">
              <a:rPr kumimoji="1" lang="ja-JP" altLang="en-US" smtClean="0"/>
              <a:t>2023/7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8BB534-52A0-0140-B7AB-67DA70CA64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06392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A1566-B2AB-954F-986E-F27DA3D5F79C}" type="datetimeFigureOut">
              <a:rPr kumimoji="1" lang="ja-JP" altLang="en-US" smtClean="0"/>
              <a:t>2023/7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8BB534-52A0-0140-B7AB-67DA70CA64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00243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864858" y="210792"/>
            <a:ext cx="1164521" cy="3355260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1297" y="210792"/>
            <a:ext cx="3426053" cy="3355260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A1566-B2AB-954F-986E-F27DA3D5F79C}" type="datetimeFigureOut">
              <a:rPr kumimoji="1" lang="ja-JP" altLang="en-US" smtClean="0"/>
              <a:t>2023/7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8BB534-52A0-0140-B7AB-67DA70CA64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3908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A1566-B2AB-954F-986E-F27DA3D5F79C}" type="datetimeFigureOut">
              <a:rPr kumimoji="1" lang="ja-JP" altLang="en-US" smtClean="0"/>
              <a:t>2023/7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8BB534-52A0-0140-B7AB-67DA70CA64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21725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8484" y="987058"/>
            <a:ext cx="4658082" cy="1646927"/>
          </a:xfrm>
        </p:spPr>
        <p:txBody>
          <a:bodyPr anchor="b"/>
          <a:lstStyle>
            <a:lvl1pPr>
              <a:defRPr sz="346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68484" y="2649566"/>
            <a:ext cx="4658082" cy="866080"/>
          </a:xfrm>
        </p:spPr>
        <p:txBody>
          <a:bodyPr/>
          <a:lstStyle>
            <a:lvl1pPr marL="0" indent="0">
              <a:buNone/>
              <a:defRPr sz="1386">
                <a:solidFill>
                  <a:schemeClr val="tx1"/>
                </a:solidFill>
              </a:defRPr>
            </a:lvl1pPr>
            <a:lvl2pPr marL="263942" indent="0">
              <a:buNone/>
              <a:defRPr sz="1155">
                <a:solidFill>
                  <a:schemeClr val="tx1">
                    <a:tint val="75000"/>
                  </a:schemeClr>
                </a:solidFill>
              </a:defRPr>
            </a:lvl2pPr>
            <a:lvl3pPr marL="527883" indent="0">
              <a:buNone/>
              <a:defRPr sz="1039">
                <a:solidFill>
                  <a:schemeClr val="tx1">
                    <a:tint val="75000"/>
                  </a:schemeClr>
                </a:solidFill>
              </a:defRPr>
            </a:lvl3pPr>
            <a:lvl4pPr marL="791825" indent="0">
              <a:buNone/>
              <a:defRPr sz="924">
                <a:solidFill>
                  <a:schemeClr val="tx1">
                    <a:tint val="75000"/>
                  </a:schemeClr>
                </a:solidFill>
              </a:defRPr>
            </a:lvl4pPr>
            <a:lvl5pPr marL="1055766" indent="0">
              <a:buNone/>
              <a:defRPr sz="924">
                <a:solidFill>
                  <a:schemeClr val="tx1">
                    <a:tint val="75000"/>
                  </a:schemeClr>
                </a:solidFill>
              </a:defRPr>
            </a:lvl5pPr>
            <a:lvl6pPr marL="1319708" indent="0">
              <a:buNone/>
              <a:defRPr sz="924">
                <a:solidFill>
                  <a:schemeClr val="tx1">
                    <a:tint val="75000"/>
                  </a:schemeClr>
                </a:solidFill>
              </a:defRPr>
            </a:lvl6pPr>
            <a:lvl7pPr marL="1583649" indent="0">
              <a:buNone/>
              <a:defRPr sz="924">
                <a:solidFill>
                  <a:schemeClr val="tx1">
                    <a:tint val="75000"/>
                  </a:schemeClr>
                </a:solidFill>
              </a:defRPr>
            </a:lvl7pPr>
            <a:lvl8pPr marL="1847591" indent="0">
              <a:buNone/>
              <a:defRPr sz="924">
                <a:solidFill>
                  <a:schemeClr val="tx1">
                    <a:tint val="75000"/>
                  </a:schemeClr>
                </a:solidFill>
              </a:defRPr>
            </a:lvl8pPr>
            <a:lvl9pPr marL="2111532" indent="0">
              <a:buNone/>
              <a:defRPr sz="92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A1566-B2AB-954F-986E-F27DA3D5F79C}" type="datetimeFigureOut">
              <a:rPr kumimoji="1" lang="ja-JP" altLang="en-US" smtClean="0"/>
              <a:t>2023/7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8BB534-52A0-0140-B7AB-67DA70CA64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35929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1296" y="1053960"/>
            <a:ext cx="2295287" cy="251209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734092" y="1053960"/>
            <a:ext cx="2295287" cy="251209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A1566-B2AB-954F-986E-F27DA3D5F79C}" type="datetimeFigureOut">
              <a:rPr kumimoji="1" lang="ja-JP" altLang="en-US" smtClean="0"/>
              <a:t>2023/7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8BB534-52A0-0140-B7AB-67DA70CA64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1158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2000" y="210793"/>
            <a:ext cx="4658082" cy="76526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2001" y="970560"/>
            <a:ext cx="2284738" cy="475657"/>
          </a:xfrm>
        </p:spPr>
        <p:txBody>
          <a:bodyPr anchor="b"/>
          <a:lstStyle>
            <a:lvl1pPr marL="0" indent="0">
              <a:buNone/>
              <a:defRPr sz="1386" b="1"/>
            </a:lvl1pPr>
            <a:lvl2pPr marL="263942" indent="0">
              <a:buNone/>
              <a:defRPr sz="1155" b="1"/>
            </a:lvl2pPr>
            <a:lvl3pPr marL="527883" indent="0">
              <a:buNone/>
              <a:defRPr sz="1039" b="1"/>
            </a:lvl3pPr>
            <a:lvl4pPr marL="791825" indent="0">
              <a:buNone/>
              <a:defRPr sz="924" b="1"/>
            </a:lvl4pPr>
            <a:lvl5pPr marL="1055766" indent="0">
              <a:buNone/>
              <a:defRPr sz="924" b="1"/>
            </a:lvl5pPr>
            <a:lvl6pPr marL="1319708" indent="0">
              <a:buNone/>
              <a:defRPr sz="924" b="1"/>
            </a:lvl6pPr>
            <a:lvl7pPr marL="1583649" indent="0">
              <a:buNone/>
              <a:defRPr sz="924" b="1"/>
            </a:lvl7pPr>
            <a:lvl8pPr marL="1847591" indent="0">
              <a:buNone/>
              <a:defRPr sz="924" b="1"/>
            </a:lvl8pPr>
            <a:lvl9pPr marL="2111532" indent="0">
              <a:buNone/>
              <a:defRPr sz="924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2001" y="1446217"/>
            <a:ext cx="2284738" cy="212716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734092" y="970560"/>
            <a:ext cx="2295990" cy="475657"/>
          </a:xfrm>
        </p:spPr>
        <p:txBody>
          <a:bodyPr anchor="b"/>
          <a:lstStyle>
            <a:lvl1pPr marL="0" indent="0">
              <a:buNone/>
              <a:defRPr sz="1386" b="1"/>
            </a:lvl1pPr>
            <a:lvl2pPr marL="263942" indent="0">
              <a:buNone/>
              <a:defRPr sz="1155" b="1"/>
            </a:lvl2pPr>
            <a:lvl3pPr marL="527883" indent="0">
              <a:buNone/>
              <a:defRPr sz="1039" b="1"/>
            </a:lvl3pPr>
            <a:lvl4pPr marL="791825" indent="0">
              <a:buNone/>
              <a:defRPr sz="924" b="1"/>
            </a:lvl4pPr>
            <a:lvl5pPr marL="1055766" indent="0">
              <a:buNone/>
              <a:defRPr sz="924" b="1"/>
            </a:lvl5pPr>
            <a:lvl6pPr marL="1319708" indent="0">
              <a:buNone/>
              <a:defRPr sz="924" b="1"/>
            </a:lvl6pPr>
            <a:lvl7pPr marL="1583649" indent="0">
              <a:buNone/>
              <a:defRPr sz="924" b="1"/>
            </a:lvl7pPr>
            <a:lvl8pPr marL="1847591" indent="0">
              <a:buNone/>
              <a:defRPr sz="924" b="1"/>
            </a:lvl8pPr>
            <a:lvl9pPr marL="2111532" indent="0">
              <a:buNone/>
              <a:defRPr sz="924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734092" y="1446217"/>
            <a:ext cx="2295990" cy="212716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A1566-B2AB-954F-986E-F27DA3D5F79C}" type="datetimeFigureOut">
              <a:rPr kumimoji="1" lang="ja-JP" altLang="en-US" smtClean="0"/>
              <a:t>2023/7/3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8BB534-52A0-0140-B7AB-67DA70CA64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74118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A1566-B2AB-954F-986E-F27DA3D5F79C}" type="datetimeFigureOut">
              <a:rPr kumimoji="1" lang="ja-JP" altLang="en-US" smtClean="0"/>
              <a:t>2023/7/3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8BB534-52A0-0140-B7AB-67DA70CA64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88643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A1566-B2AB-954F-986E-F27DA3D5F79C}" type="datetimeFigureOut">
              <a:rPr kumimoji="1" lang="ja-JP" altLang="en-US" smtClean="0"/>
              <a:t>2023/7/3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8BB534-52A0-0140-B7AB-67DA70CA64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22067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2000" y="263948"/>
            <a:ext cx="1741858" cy="923819"/>
          </a:xfrm>
        </p:spPr>
        <p:txBody>
          <a:bodyPr anchor="b"/>
          <a:lstStyle>
            <a:lvl1pPr>
              <a:defRPr sz="184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295990" y="570056"/>
            <a:ext cx="2734092" cy="2813616"/>
          </a:xfrm>
        </p:spPr>
        <p:txBody>
          <a:bodyPr/>
          <a:lstStyle>
            <a:lvl1pPr>
              <a:defRPr sz="1847"/>
            </a:lvl1pPr>
            <a:lvl2pPr>
              <a:defRPr sz="1616"/>
            </a:lvl2pPr>
            <a:lvl3pPr>
              <a:defRPr sz="1386"/>
            </a:lvl3pPr>
            <a:lvl4pPr>
              <a:defRPr sz="1155"/>
            </a:lvl4pPr>
            <a:lvl5pPr>
              <a:defRPr sz="1155"/>
            </a:lvl5pPr>
            <a:lvl6pPr>
              <a:defRPr sz="1155"/>
            </a:lvl6pPr>
            <a:lvl7pPr>
              <a:defRPr sz="1155"/>
            </a:lvl7pPr>
            <a:lvl8pPr>
              <a:defRPr sz="1155"/>
            </a:lvl8pPr>
            <a:lvl9pPr>
              <a:defRPr sz="1155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72000" y="1187768"/>
            <a:ext cx="1741858" cy="2200486"/>
          </a:xfrm>
        </p:spPr>
        <p:txBody>
          <a:bodyPr/>
          <a:lstStyle>
            <a:lvl1pPr marL="0" indent="0">
              <a:buNone/>
              <a:defRPr sz="924"/>
            </a:lvl1pPr>
            <a:lvl2pPr marL="263942" indent="0">
              <a:buNone/>
              <a:defRPr sz="808"/>
            </a:lvl2pPr>
            <a:lvl3pPr marL="527883" indent="0">
              <a:buNone/>
              <a:defRPr sz="693"/>
            </a:lvl3pPr>
            <a:lvl4pPr marL="791825" indent="0">
              <a:buNone/>
              <a:defRPr sz="577"/>
            </a:lvl4pPr>
            <a:lvl5pPr marL="1055766" indent="0">
              <a:buNone/>
              <a:defRPr sz="577"/>
            </a:lvl5pPr>
            <a:lvl6pPr marL="1319708" indent="0">
              <a:buNone/>
              <a:defRPr sz="577"/>
            </a:lvl6pPr>
            <a:lvl7pPr marL="1583649" indent="0">
              <a:buNone/>
              <a:defRPr sz="577"/>
            </a:lvl7pPr>
            <a:lvl8pPr marL="1847591" indent="0">
              <a:buNone/>
              <a:defRPr sz="577"/>
            </a:lvl8pPr>
            <a:lvl9pPr marL="2111532" indent="0">
              <a:buNone/>
              <a:defRPr sz="57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A1566-B2AB-954F-986E-F27DA3D5F79C}" type="datetimeFigureOut">
              <a:rPr kumimoji="1" lang="ja-JP" altLang="en-US" smtClean="0"/>
              <a:t>2023/7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8BB534-52A0-0140-B7AB-67DA70CA64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15396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2000" y="263948"/>
            <a:ext cx="1741858" cy="923819"/>
          </a:xfrm>
        </p:spPr>
        <p:txBody>
          <a:bodyPr anchor="b"/>
          <a:lstStyle>
            <a:lvl1pPr>
              <a:defRPr sz="184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295990" y="570056"/>
            <a:ext cx="2734092" cy="2813616"/>
          </a:xfrm>
        </p:spPr>
        <p:txBody>
          <a:bodyPr anchor="t"/>
          <a:lstStyle>
            <a:lvl1pPr marL="0" indent="0">
              <a:buNone/>
              <a:defRPr sz="1847"/>
            </a:lvl1pPr>
            <a:lvl2pPr marL="263942" indent="0">
              <a:buNone/>
              <a:defRPr sz="1616"/>
            </a:lvl2pPr>
            <a:lvl3pPr marL="527883" indent="0">
              <a:buNone/>
              <a:defRPr sz="1386"/>
            </a:lvl3pPr>
            <a:lvl4pPr marL="791825" indent="0">
              <a:buNone/>
              <a:defRPr sz="1155"/>
            </a:lvl4pPr>
            <a:lvl5pPr marL="1055766" indent="0">
              <a:buNone/>
              <a:defRPr sz="1155"/>
            </a:lvl5pPr>
            <a:lvl6pPr marL="1319708" indent="0">
              <a:buNone/>
              <a:defRPr sz="1155"/>
            </a:lvl6pPr>
            <a:lvl7pPr marL="1583649" indent="0">
              <a:buNone/>
              <a:defRPr sz="1155"/>
            </a:lvl7pPr>
            <a:lvl8pPr marL="1847591" indent="0">
              <a:buNone/>
              <a:defRPr sz="1155"/>
            </a:lvl8pPr>
            <a:lvl9pPr marL="2111532" indent="0">
              <a:buNone/>
              <a:defRPr sz="1155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72000" y="1187768"/>
            <a:ext cx="1741858" cy="2200486"/>
          </a:xfrm>
        </p:spPr>
        <p:txBody>
          <a:bodyPr/>
          <a:lstStyle>
            <a:lvl1pPr marL="0" indent="0">
              <a:buNone/>
              <a:defRPr sz="924"/>
            </a:lvl1pPr>
            <a:lvl2pPr marL="263942" indent="0">
              <a:buNone/>
              <a:defRPr sz="808"/>
            </a:lvl2pPr>
            <a:lvl3pPr marL="527883" indent="0">
              <a:buNone/>
              <a:defRPr sz="693"/>
            </a:lvl3pPr>
            <a:lvl4pPr marL="791825" indent="0">
              <a:buNone/>
              <a:defRPr sz="577"/>
            </a:lvl4pPr>
            <a:lvl5pPr marL="1055766" indent="0">
              <a:buNone/>
              <a:defRPr sz="577"/>
            </a:lvl5pPr>
            <a:lvl6pPr marL="1319708" indent="0">
              <a:buNone/>
              <a:defRPr sz="577"/>
            </a:lvl6pPr>
            <a:lvl7pPr marL="1583649" indent="0">
              <a:buNone/>
              <a:defRPr sz="577"/>
            </a:lvl7pPr>
            <a:lvl8pPr marL="1847591" indent="0">
              <a:buNone/>
              <a:defRPr sz="577"/>
            </a:lvl8pPr>
            <a:lvl9pPr marL="2111532" indent="0">
              <a:buNone/>
              <a:defRPr sz="57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A1566-B2AB-954F-986E-F27DA3D5F79C}" type="datetimeFigureOut">
              <a:rPr kumimoji="1" lang="ja-JP" altLang="en-US" smtClean="0"/>
              <a:t>2023/7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8BB534-52A0-0140-B7AB-67DA70CA64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1890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71297" y="210793"/>
            <a:ext cx="4658082" cy="76526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1297" y="1053960"/>
            <a:ext cx="4658082" cy="251209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71296" y="3669616"/>
            <a:ext cx="1215152" cy="2107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9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BA1566-B2AB-954F-986E-F27DA3D5F79C}" type="datetimeFigureOut">
              <a:rPr kumimoji="1" lang="ja-JP" altLang="en-US" smtClean="0"/>
              <a:t>2023/7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788974" y="3669616"/>
            <a:ext cx="1822728" cy="2107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9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814227" y="3669616"/>
            <a:ext cx="1215152" cy="2107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9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8BB534-52A0-0140-B7AB-67DA70CA64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68306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527883" rtl="0" eaLnBrk="1" latinLnBrk="0" hangingPunct="1">
        <a:lnSpc>
          <a:spcPct val="90000"/>
        </a:lnSpc>
        <a:spcBef>
          <a:spcPct val="0"/>
        </a:spcBef>
        <a:buNone/>
        <a:defRPr kumimoji="1" sz="25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1971" indent="-131971" algn="l" defTabSz="527883" rtl="0" eaLnBrk="1" latinLnBrk="0" hangingPunct="1">
        <a:lnSpc>
          <a:spcPct val="90000"/>
        </a:lnSpc>
        <a:spcBef>
          <a:spcPts val="577"/>
        </a:spcBef>
        <a:buFont typeface="Arial" panose="020B0604020202020204" pitchFamily="34" charset="0"/>
        <a:buChar char="•"/>
        <a:defRPr kumimoji="1" sz="1616" kern="1200">
          <a:solidFill>
            <a:schemeClr val="tx1"/>
          </a:solidFill>
          <a:latin typeface="+mn-lt"/>
          <a:ea typeface="+mn-ea"/>
          <a:cs typeface="+mn-cs"/>
        </a:defRPr>
      </a:lvl1pPr>
      <a:lvl2pPr marL="395912" indent="-131971" algn="l" defTabSz="527883" rtl="0" eaLnBrk="1" latinLnBrk="0" hangingPunct="1">
        <a:lnSpc>
          <a:spcPct val="90000"/>
        </a:lnSpc>
        <a:spcBef>
          <a:spcPts val="289"/>
        </a:spcBef>
        <a:buFont typeface="Arial" panose="020B0604020202020204" pitchFamily="34" charset="0"/>
        <a:buChar char="•"/>
        <a:defRPr kumimoji="1" sz="1386" kern="1200">
          <a:solidFill>
            <a:schemeClr val="tx1"/>
          </a:solidFill>
          <a:latin typeface="+mn-lt"/>
          <a:ea typeface="+mn-ea"/>
          <a:cs typeface="+mn-cs"/>
        </a:defRPr>
      </a:lvl2pPr>
      <a:lvl3pPr marL="659854" indent="-131971" algn="l" defTabSz="527883" rtl="0" eaLnBrk="1" latinLnBrk="0" hangingPunct="1">
        <a:lnSpc>
          <a:spcPct val="90000"/>
        </a:lnSpc>
        <a:spcBef>
          <a:spcPts val="289"/>
        </a:spcBef>
        <a:buFont typeface="Arial" panose="020B0604020202020204" pitchFamily="34" charset="0"/>
        <a:buChar char="•"/>
        <a:defRPr kumimoji="1" sz="1155" kern="1200">
          <a:solidFill>
            <a:schemeClr val="tx1"/>
          </a:solidFill>
          <a:latin typeface="+mn-lt"/>
          <a:ea typeface="+mn-ea"/>
          <a:cs typeface="+mn-cs"/>
        </a:defRPr>
      </a:lvl3pPr>
      <a:lvl4pPr marL="923795" indent="-131971" algn="l" defTabSz="527883" rtl="0" eaLnBrk="1" latinLnBrk="0" hangingPunct="1">
        <a:lnSpc>
          <a:spcPct val="90000"/>
        </a:lnSpc>
        <a:spcBef>
          <a:spcPts val="289"/>
        </a:spcBef>
        <a:buFont typeface="Arial" panose="020B0604020202020204" pitchFamily="34" charset="0"/>
        <a:buChar char="•"/>
        <a:defRPr kumimoji="1" sz="1039" kern="1200">
          <a:solidFill>
            <a:schemeClr val="tx1"/>
          </a:solidFill>
          <a:latin typeface="+mn-lt"/>
          <a:ea typeface="+mn-ea"/>
          <a:cs typeface="+mn-cs"/>
        </a:defRPr>
      </a:lvl4pPr>
      <a:lvl5pPr marL="1187737" indent="-131971" algn="l" defTabSz="527883" rtl="0" eaLnBrk="1" latinLnBrk="0" hangingPunct="1">
        <a:lnSpc>
          <a:spcPct val="90000"/>
        </a:lnSpc>
        <a:spcBef>
          <a:spcPts val="289"/>
        </a:spcBef>
        <a:buFont typeface="Arial" panose="020B0604020202020204" pitchFamily="34" charset="0"/>
        <a:buChar char="•"/>
        <a:defRPr kumimoji="1" sz="1039" kern="1200">
          <a:solidFill>
            <a:schemeClr val="tx1"/>
          </a:solidFill>
          <a:latin typeface="+mn-lt"/>
          <a:ea typeface="+mn-ea"/>
          <a:cs typeface="+mn-cs"/>
        </a:defRPr>
      </a:lvl5pPr>
      <a:lvl6pPr marL="1451679" indent="-131971" algn="l" defTabSz="527883" rtl="0" eaLnBrk="1" latinLnBrk="0" hangingPunct="1">
        <a:lnSpc>
          <a:spcPct val="90000"/>
        </a:lnSpc>
        <a:spcBef>
          <a:spcPts val="289"/>
        </a:spcBef>
        <a:buFont typeface="Arial" panose="020B0604020202020204" pitchFamily="34" charset="0"/>
        <a:buChar char="•"/>
        <a:defRPr kumimoji="1" sz="1039" kern="1200">
          <a:solidFill>
            <a:schemeClr val="tx1"/>
          </a:solidFill>
          <a:latin typeface="+mn-lt"/>
          <a:ea typeface="+mn-ea"/>
          <a:cs typeface="+mn-cs"/>
        </a:defRPr>
      </a:lvl6pPr>
      <a:lvl7pPr marL="1715620" indent="-131971" algn="l" defTabSz="527883" rtl="0" eaLnBrk="1" latinLnBrk="0" hangingPunct="1">
        <a:lnSpc>
          <a:spcPct val="90000"/>
        </a:lnSpc>
        <a:spcBef>
          <a:spcPts val="289"/>
        </a:spcBef>
        <a:buFont typeface="Arial" panose="020B0604020202020204" pitchFamily="34" charset="0"/>
        <a:buChar char="•"/>
        <a:defRPr kumimoji="1" sz="1039" kern="1200">
          <a:solidFill>
            <a:schemeClr val="tx1"/>
          </a:solidFill>
          <a:latin typeface="+mn-lt"/>
          <a:ea typeface="+mn-ea"/>
          <a:cs typeface="+mn-cs"/>
        </a:defRPr>
      </a:lvl7pPr>
      <a:lvl8pPr marL="1979562" indent="-131971" algn="l" defTabSz="527883" rtl="0" eaLnBrk="1" latinLnBrk="0" hangingPunct="1">
        <a:lnSpc>
          <a:spcPct val="90000"/>
        </a:lnSpc>
        <a:spcBef>
          <a:spcPts val="289"/>
        </a:spcBef>
        <a:buFont typeface="Arial" panose="020B0604020202020204" pitchFamily="34" charset="0"/>
        <a:buChar char="•"/>
        <a:defRPr kumimoji="1" sz="1039" kern="1200">
          <a:solidFill>
            <a:schemeClr val="tx1"/>
          </a:solidFill>
          <a:latin typeface="+mn-lt"/>
          <a:ea typeface="+mn-ea"/>
          <a:cs typeface="+mn-cs"/>
        </a:defRPr>
      </a:lvl8pPr>
      <a:lvl9pPr marL="2243503" indent="-131971" algn="l" defTabSz="527883" rtl="0" eaLnBrk="1" latinLnBrk="0" hangingPunct="1">
        <a:lnSpc>
          <a:spcPct val="90000"/>
        </a:lnSpc>
        <a:spcBef>
          <a:spcPts val="289"/>
        </a:spcBef>
        <a:buFont typeface="Arial" panose="020B0604020202020204" pitchFamily="34" charset="0"/>
        <a:buChar char="•"/>
        <a:defRPr kumimoji="1" sz="103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27883" rtl="0" eaLnBrk="1" latinLnBrk="0" hangingPunct="1">
        <a:defRPr kumimoji="1" sz="1039" kern="1200">
          <a:solidFill>
            <a:schemeClr val="tx1"/>
          </a:solidFill>
          <a:latin typeface="+mn-lt"/>
          <a:ea typeface="+mn-ea"/>
          <a:cs typeface="+mn-cs"/>
        </a:defRPr>
      </a:lvl1pPr>
      <a:lvl2pPr marL="263942" algn="l" defTabSz="527883" rtl="0" eaLnBrk="1" latinLnBrk="0" hangingPunct="1">
        <a:defRPr kumimoji="1" sz="1039" kern="1200">
          <a:solidFill>
            <a:schemeClr val="tx1"/>
          </a:solidFill>
          <a:latin typeface="+mn-lt"/>
          <a:ea typeface="+mn-ea"/>
          <a:cs typeface="+mn-cs"/>
        </a:defRPr>
      </a:lvl2pPr>
      <a:lvl3pPr marL="527883" algn="l" defTabSz="527883" rtl="0" eaLnBrk="1" latinLnBrk="0" hangingPunct="1">
        <a:defRPr kumimoji="1" sz="1039" kern="1200">
          <a:solidFill>
            <a:schemeClr val="tx1"/>
          </a:solidFill>
          <a:latin typeface="+mn-lt"/>
          <a:ea typeface="+mn-ea"/>
          <a:cs typeface="+mn-cs"/>
        </a:defRPr>
      </a:lvl3pPr>
      <a:lvl4pPr marL="791825" algn="l" defTabSz="527883" rtl="0" eaLnBrk="1" latinLnBrk="0" hangingPunct="1">
        <a:defRPr kumimoji="1" sz="1039" kern="1200">
          <a:solidFill>
            <a:schemeClr val="tx1"/>
          </a:solidFill>
          <a:latin typeface="+mn-lt"/>
          <a:ea typeface="+mn-ea"/>
          <a:cs typeface="+mn-cs"/>
        </a:defRPr>
      </a:lvl4pPr>
      <a:lvl5pPr marL="1055766" algn="l" defTabSz="527883" rtl="0" eaLnBrk="1" latinLnBrk="0" hangingPunct="1">
        <a:defRPr kumimoji="1" sz="1039" kern="1200">
          <a:solidFill>
            <a:schemeClr val="tx1"/>
          </a:solidFill>
          <a:latin typeface="+mn-lt"/>
          <a:ea typeface="+mn-ea"/>
          <a:cs typeface="+mn-cs"/>
        </a:defRPr>
      </a:lvl5pPr>
      <a:lvl6pPr marL="1319708" algn="l" defTabSz="527883" rtl="0" eaLnBrk="1" latinLnBrk="0" hangingPunct="1">
        <a:defRPr kumimoji="1" sz="1039" kern="1200">
          <a:solidFill>
            <a:schemeClr val="tx1"/>
          </a:solidFill>
          <a:latin typeface="+mn-lt"/>
          <a:ea typeface="+mn-ea"/>
          <a:cs typeface="+mn-cs"/>
        </a:defRPr>
      </a:lvl6pPr>
      <a:lvl7pPr marL="1583649" algn="l" defTabSz="527883" rtl="0" eaLnBrk="1" latinLnBrk="0" hangingPunct="1">
        <a:defRPr kumimoji="1" sz="1039" kern="1200">
          <a:solidFill>
            <a:schemeClr val="tx1"/>
          </a:solidFill>
          <a:latin typeface="+mn-lt"/>
          <a:ea typeface="+mn-ea"/>
          <a:cs typeface="+mn-cs"/>
        </a:defRPr>
      </a:lvl7pPr>
      <a:lvl8pPr marL="1847591" algn="l" defTabSz="527883" rtl="0" eaLnBrk="1" latinLnBrk="0" hangingPunct="1">
        <a:defRPr kumimoji="1" sz="1039" kern="1200">
          <a:solidFill>
            <a:schemeClr val="tx1"/>
          </a:solidFill>
          <a:latin typeface="+mn-lt"/>
          <a:ea typeface="+mn-ea"/>
          <a:cs typeface="+mn-cs"/>
        </a:defRPr>
      </a:lvl8pPr>
      <a:lvl9pPr marL="2111532" algn="l" defTabSz="527883" rtl="0" eaLnBrk="1" latinLnBrk="0" hangingPunct="1">
        <a:defRPr kumimoji="1" sz="103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33443516-7DF5-317F-3AD6-72CA7C662470}"/>
              </a:ext>
            </a:extLst>
          </p:cNvPr>
          <p:cNvSpPr txBox="1"/>
          <p:nvPr/>
        </p:nvSpPr>
        <p:spPr>
          <a:xfrm>
            <a:off x="149390" y="3244936"/>
            <a:ext cx="5101896" cy="67710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ig. S</a:t>
            </a:r>
            <a:r>
              <a:rPr lang="ja-JP" altLang="en-US" sz="1200">
                <a:latin typeface="Arial" panose="020B0604020202020204" pitchFamily="34" charset="0"/>
                <a:cs typeface="Arial" panose="020B0604020202020204" pitchFamily="34" charset="0"/>
              </a:rPr>
              <a:t>1. Classification of sites for all lineages</a:t>
            </a:r>
          </a:p>
          <a:p>
            <a:r>
              <a:rPr lang="en-GB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Each site was classified as STABLE, DOWN, UP, and OTHER depending on the time-course changes in chromatin states through all lineages and then summarized.</a:t>
            </a: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B20F4F62-097B-BE6A-9483-15619E355FC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8268" y="192856"/>
            <a:ext cx="4997539" cy="27187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705974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75</TotalTime>
  <Words>40</Words>
  <Application>Microsoft Macintosh PowerPoint</Application>
  <PresentationFormat>ユーザー設定</PresentationFormat>
  <Paragraphs>3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小柳　香奈子</dc:creator>
  <cp:lastModifiedBy>kkoyanag</cp:lastModifiedBy>
  <cp:revision>78</cp:revision>
  <dcterms:created xsi:type="dcterms:W3CDTF">2022-10-21T02:02:22Z</dcterms:created>
  <dcterms:modified xsi:type="dcterms:W3CDTF">2023-07-31T01:20:11Z</dcterms:modified>
</cp:coreProperties>
</file>